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4" autoAdjust="0"/>
    <p:restoredTop sz="94694"/>
  </p:normalViewPr>
  <p:slideViewPr>
    <p:cSldViewPr snapToGrid="0">
      <p:cViewPr varScale="1">
        <p:scale>
          <a:sx n="102" d="100"/>
          <a:sy n="102" d="100"/>
        </p:scale>
        <p:origin x="87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8151009-3E16-078C-93B2-3BDA24007CF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9C87A077-08AA-F490-FA5D-E5089CE67CD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C736962-80A4-940C-D8E7-4423679449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B73BCB-ED80-4257-B6BE-DAAA0FDB651A}" type="datetimeFigureOut">
              <a:rPr lang="es-ES" smtClean="0"/>
              <a:t>31/01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3EBD18A-658F-F97D-E10E-99467784AE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5C89C484-3630-9A89-88E1-B52C311B9E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787D4-07D6-45D2-A60C-4F9ADFA37BD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561022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FD82623-B1D8-CF4E-1F4B-57C192B17C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23C9A59F-C673-EF72-52CB-BDA4F1E44DD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DED17B0-3A6A-7799-4640-0B0186BCEC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B73BCB-ED80-4257-B6BE-DAAA0FDB651A}" type="datetimeFigureOut">
              <a:rPr lang="es-ES" smtClean="0"/>
              <a:t>31/01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55A008BB-F246-E51D-5CB7-3D2155FE6E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C8873F8B-6556-27B8-4557-710F12A5DB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787D4-07D6-45D2-A60C-4F9ADFA37BD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886593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239899BD-971A-45F5-8647-EB2ECDE60CF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B1618F1A-FC3B-FF22-29F2-596E5C5CBBB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8E802A0-D5CF-359E-8C18-DA0BE13BBE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B73BCB-ED80-4257-B6BE-DAAA0FDB651A}" type="datetimeFigureOut">
              <a:rPr lang="es-ES" smtClean="0"/>
              <a:t>31/01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0506CE9-DEF3-D4AF-0196-88EB8776C6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1C8ED7DB-7727-3122-DB81-1FE90D1F40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787D4-07D6-45D2-A60C-4F9ADFA37BD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241977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EAB399D-0E4E-4968-4A88-17271C31FB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C1D0FE61-312F-2905-D998-E87E87B4D97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712BEF8-3717-C711-0754-4790ACCF97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B73BCB-ED80-4257-B6BE-DAAA0FDB651A}" type="datetimeFigureOut">
              <a:rPr lang="es-ES" smtClean="0"/>
              <a:t>31/01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A8AE1C1-7810-0828-B1A0-AD02C28665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38ACE37-1F87-4C6F-CF80-43A2914009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787D4-07D6-45D2-A60C-4F9ADFA37BD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972815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54B7435-00E4-FC01-576F-D5C462F7A5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6158B10A-4AE0-DBD2-2E3A-70B4A6ED28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CE9B78F-F945-29B2-4854-5011168DE9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B73BCB-ED80-4257-B6BE-DAAA0FDB651A}" type="datetimeFigureOut">
              <a:rPr lang="es-ES" smtClean="0"/>
              <a:t>31/01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C5068B5-9F5A-77E2-6311-5FF7F06D0D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23E8BD85-E7BD-8E18-1301-E61370CDF6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787D4-07D6-45D2-A60C-4F9ADFA37BD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372500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6CB8A5D-4FB2-8030-0368-26F4EE146E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8578105D-EB9C-4912-AC18-98609E59A81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F48701DC-3EF6-74F4-A4E6-8215B9E989B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C0B7B17F-4D2E-B809-BD18-21BEAD2D5B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B73BCB-ED80-4257-B6BE-DAAA0FDB651A}" type="datetimeFigureOut">
              <a:rPr lang="es-ES" smtClean="0"/>
              <a:t>31/01/20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0D11485A-FB16-E196-0FCC-33162AEA9A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417D332F-8E2A-4D85-D92D-B6AB4E1DBA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787D4-07D6-45D2-A60C-4F9ADFA37BD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888276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50C2242-4B98-AFE5-D144-78F00423CC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6928E8B9-2052-E357-40B6-977B7E8288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285A19EE-5EDC-4B13-3B38-9F103E3E289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779FCE93-1789-FE65-62DB-DFFF3DC4979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8603C47D-21B7-7D69-8D14-E61F55901BB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1C3C163E-CE11-3669-1206-CE76124592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B73BCB-ED80-4257-B6BE-DAAA0FDB651A}" type="datetimeFigureOut">
              <a:rPr lang="es-ES" smtClean="0"/>
              <a:t>31/01/2025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26C279B7-F458-3222-9059-5FD675A9C3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CD295ACD-DC53-F627-647C-557171C998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787D4-07D6-45D2-A60C-4F9ADFA37BD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99387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77979EB-6D1D-4127-8404-FB9A9C8A85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981823F0-DA4F-E84F-2ED2-94E9B5FC98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B73BCB-ED80-4257-B6BE-DAAA0FDB651A}" type="datetimeFigureOut">
              <a:rPr lang="es-ES" smtClean="0"/>
              <a:t>31/01/2025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14D4FC27-AF7A-9852-5175-BC2818B313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2721DBB2-297D-D94C-0DD9-3A3BBC9B81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787D4-07D6-45D2-A60C-4F9ADFA37BD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560482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2EB2CAF2-38D3-8E80-3552-7A125AF58B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B73BCB-ED80-4257-B6BE-DAAA0FDB651A}" type="datetimeFigureOut">
              <a:rPr lang="es-ES" smtClean="0"/>
              <a:t>31/01/2025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7441B4E3-9427-1545-CA45-465DA22278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5F8AD67B-6C04-FF42-FEE6-ACB45DF280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787D4-07D6-45D2-A60C-4F9ADFA37BD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06344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D78F0BC-8BC8-88D6-BDC7-E873DF122E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2E05B3DD-46C6-6C9D-7601-301F8ED6E00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F95CE93D-CAED-1C6B-BDF8-4203D1ECD31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DD96179E-649E-DE78-75D9-E25C99ADF2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B73BCB-ED80-4257-B6BE-DAAA0FDB651A}" type="datetimeFigureOut">
              <a:rPr lang="es-ES" smtClean="0"/>
              <a:t>31/01/20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D92E905B-FC73-8733-5C43-8534D2AD69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F43FA256-A344-C247-77FA-7319098A31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787D4-07D6-45D2-A60C-4F9ADFA37BD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03058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6677D1F-DB66-94FB-0796-73F9597294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A536179D-F71E-9387-F3E1-AFD132A4CCD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AEC3D056-02B9-3417-8EB6-18040DC8787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E40F2C21-6A61-94B5-38BE-011743B162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B73BCB-ED80-4257-B6BE-DAAA0FDB651A}" type="datetimeFigureOut">
              <a:rPr lang="es-ES" smtClean="0"/>
              <a:t>31/01/20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E392FD94-A491-64D1-AB31-742A21968E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933CF4C8-539B-6A8C-E4E8-15D95063E5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787D4-07D6-45D2-A60C-4F9ADFA37BD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369122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DBFF1252-96A1-77FD-39BB-AE02F71288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AA0FDB38-8C6D-37F7-7D3D-762B00DCA7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89739EE-35F0-E1C3-B0C4-0912B73A2B7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1B73BCB-ED80-4257-B6BE-DAAA0FDB651A}" type="datetimeFigureOut">
              <a:rPr lang="es-ES" smtClean="0"/>
              <a:t>31/01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43C1CC6-B868-A114-244D-405C5110AB0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07B9D4D-DA30-D177-95F2-A5F7542E463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59787D4-07D6-45D2-A60C-4F9ADFA37BD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936159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upo 8">
            <a:extLst>
              <a:ext uri="{FF2B5EF4-FFF2-40B4-BE49-F238E27FC236}">
                <a16:creationId xmlns:a16="http://schemas.microsoft.com/office/drawing/2014/main" id="{6A2ECB20-E8E4-22AE-BC08-5A6F9FC45FEB}"/>
              </a:ext>
            </a:extLst>
          </p:cNvPr>
          <p:cNvGrpSpPr/>
          <p:nvPr/>
        </p:nvGrpSpPr>
        <p:grpSpPr>
          <a:xfrm>
            <a:off x="7157545" y="103695"/>
            <a:ext cx="4803227" cy="6743188"/>
            <a:chOff x="3433958" y="0"/>
            <a:chExt cx="4803227" cy="6849157"/>
          </a:xfrm>
        </p:grpSpPr>
        <p:pic>
          <p:nvPicPr>
            <p:cNvPr id="7" name="Imagen 6">
              <a:extLst>
                <a:ext uri="{FF2B5EF4-FFF2-40B4-BE49-F238E27FC236}">
                  <a16:creationId xmlns:a16="http://schemas.microsoft.com/office/drawing/2014/main" id="{6D76B18C-DA21-09BE-B734-4B8D8647C46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652380" y="0"/>
              <a:ext cx="4266135" cy="5986437"/>
            </a:xfrm>
            <a:prstGeom prst="rect">
              <a:avLst/>
            </a:prstGeom>
          </p:spPr>
        </p:pic>
        <p:sp>
          <p:nvSpPr>
            <p:cNvPr id="8" name="CuadroTexto 7">
              <a:extLst>
                <a:ext uri="{FF2B5EF4-FFF2-40B4-BE49-F238E27FC236}">
                  <a16:creationId xmlns:a16="http://schemas.microsoft.com/office/drawing/2014/main" id="{A72CC12D-1D86-3E3F-DFE8-A23733BAA773}"/>
                </a:ext>
              </a:extLst>
            </p:cNvPr>
            <p:cNvSpPr txBox="1"/>
            <p:nvPr/>
          </p:nvSpPr>
          <p:spPr>
            <a:xfrm>
              <a:off x="3433958" y="6192669"/>
              <a:ext cx="4803227" cy="6564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2: Bioinformatics pipeline for the annotation of the </a:t>
              </a:r>
              <a:r>
                <a:rPr lang="en-US" sz="12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r>
                <a:rPr lang="en-US" sz="12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1200" b="1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ecussatus</a:t>
              </a:r>
              <a:r>
                <a:rPr lang="en-US" sz="12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enome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Genomes are shown in dark blue, input data in orange, programs in light blue, and intermediate data and outputs in white.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11" name="Imagen 10">
            <a:extLst>
              <a:ext uri="{FF2B5EF4-FFF2-40B4-BE49-F238E27FC236}">
                <a16:creationId xmlns:a16="http://schemas.microsoft.com/office/drawing/2014/main" id="{D73AAAE5-9E69-72E8-6EDB-1E8C7D12FF9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49898" y="754144"/>
            <a:ext cx="5340528" cy="5170602"/>
          </a:xfrm>
          <a:prstGeom prst="rect">
            <a:avLst/>
          </a:prstGeom>
        </p:spPr>
      </p:pic>
      <p:sp>
        <p:nvSpPr>
          <p:cNvPr id="12" name="CuadroTexto 11">
            <a:extLst>
              <a:ext uri="{FF2B5EF4-FFF2-40B4-BE49-F238E27FC236}">
                <a16:creationId xmlns:a16="http://schemas.microsoft.com/office/drawing/2014/main" id="{F9C17CC8-ED7B-A9A0-25A2-CC95A43BAB82}"/>
              </a:ext>
            </a:extLst>
          </p:cNvPr>
          <p:cNvSpPr txBox="1"/>
          <p:nvPr/>
        </p:nvSpPr>
        <p:spPr>
          <a:xfrm>
            <a:off x="819807" y="6164414"/>
            <a:ext cx="507061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: Bioinformatics pipeline for the assembly of the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cussatus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ome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put data is shown in pink, main programs in yellow, processing in blue, output in orange, and intermediate data in white.</a:t>
            </a:r>
          </a:p>
        </p:txBody>
      </p:sp>
    </p:spTree>
    <p:extLst>
      <p:ext uri="{BB962C8B-B14F-4D97-AF65-F5344CB8AC3E}">
        <p14:creationId xmlns:p14="http://schemas.microsoft.com/office/powerpoint/2010/main" val="299629164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81</Words>
  <Application>Microsoft Office PowerPoint</Application>
  <PresentationFormat>Panorámica</PresentationFormat>
  <Paragraphs>2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Tema de Office</vt:lpstr>
      <vt:lpstr>Presentación de PowerPoint</vt:lpstr>
    </vt:vector>
  </TitlesOfParts>
  <Company>Us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TINEZ PORTELA PAULINO</dc:creator>
  <cp:lastModifiedBy>MARTINEZ PORTELA PAULINO</cp:lastModifiedBy>
  <cp:revision>5</cp:revision>
  <dcterms:created xsi:type="dcterms:W3CDTF">2024-10-04T10:59:48Z</dcterms:created>
  <dcterms:modified xsi:type="dcterms:W3CDTF">2025-01-31T15:48:15Z</dcterms:modified>
</cp:coreProperties>
</file>